
<file path=[Content_Types].xml><?xml version="1.0" encoding="utf-8"?>
<Types xmlns="http://schemas.openxmlformats.org/package/2006/content-types">
  <Default Extension="jpeg" ContentType="image/jpeg"/>
  <Default Extension="jp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4"/>
  </p:notesMasterIdLst>
  <p:sldIdLst>
    <p:sldId id="261" r:id="rId2"/>
    <p:sldId id="258" r:id="rId3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74" autoAdjust="0"/>
    <p:restoredTop sz="84762"/>
  </p:normalViewPr>
  <p:slideViewPr>
    <p:cSldViewPr snapToGrid="0">
      <p:cViewPr>
        <p:scale>
          <a:sx n="100" d="100"/>
          <a:sy n="100" d="100"/>
        </p:scale>
        <p:origin x="72" y="-88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1EEE3D5-6DF5-F749-9DF9-5A0C653B3797}" type="datetimeFigureOut">
              <a:rPr lang="en-US" smtClean="0"/>
              <a:t>6/11/2021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BB41357-370C-004A-B8D9-68B9C8119CF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616770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CA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Figure S1: Principal Coordinate Analysis (PCA)of microbial communities based on A – ITS2 (fungal) and B – 16S rRNA (bacterial) communities Weighted </a:t>
            </a:r>
            <a:r>
              <a:rPr lang="en-CA" sz="1200" dirty="0" err="1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Unifrac</a:t>
            </a:r>
            <a:r>
              <a:rPr lang="en-CA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 dissimilarity matrix.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CA" dirty="0">
                <a:latin typeface="Times New Roman" panose="02020603050405020304" pitchFamily="18" charset="0"/>
                <a:cs typeface="Times New Roman" panose="02020603050405020304" pitchFamily="18" charset="0"/>
              </a:rPr>
              <a:t>Point sizes are proportionate to Shannon diversity index.</a:t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20A3BD7B-A76F-B340-9631-C7ADF60A40F2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07766224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CA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Figure S2: </a:t>
            </a:r>
            <a:r>
              <a:rPr lang="en-CA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Eukaryotic taxa that were significantly overrepresented in comparison between </a:t>
            </a:r>
            <a:r>
              <a:rPr lang="en-CA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prothioconazole and UTG.</a:t>
            </a:r>
          </a:p>
          <a:p>
            <a:r>
              <a:rPr lang="en-CA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Corrected P-values (</a:t>
            </a:r>
            <a:r>
              <a:rPr lang="en-CA" sz="1200" i="1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q</a:t>
            </a:r>
            <a:r>
              <a:rPr lang="en-CA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-values) were calculated based on </a:t>
            </a:r>
            <a:r>
              <a:rPr lang="en-CA" sz="120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Benjamini</a:t>
            </a:r>
            <a:r>
              <a:rPr lang="en-CA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-Hochberg FDR multiple test correction. Features with (Welch's </a:t>
            </a:r>
            <a:r>
              <a:rPr lang="en-CA" sz="1200" i="1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t</a:t>
            </a:r>
            <a:r>
              <a:rPr lang="en-CA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-test) </a:t>
            </a:r>
            <a:r>
              <a:rPr lang="en-CA" sz="1200" i="1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q </a:t>
            </a:r>
            <a:r>
              <a:rPr lang="en-CA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value &lt;0.05 were considered significant and were thus retained. </a:t>
            </a:r>
            <a:endParaRPr lang="en-CA" dirty="0"/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FBB41357-370C-004A-B8D9-68B9C8119CF1}" type="slidenum">
              <a:rPr lang="en-US" smtClean="0"/>
              <a:t>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67906399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7EC6762-CCF9-488B-9BF2-30DABFFCD8B7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9CE4D4F9-9918-45D3-94AE-0259FBC56A86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CA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9F2BAF6-387C-4E1C-8921-40FF93D66D8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18210F-8F47-4556-9859-DDA34A5D551C}" type="datetimeFigureOut">
              <a:rPr lang="en-CA" smtClean="0"/>
              <a:t>2021-06-11</a:t>
            </a:fld>
            <a:endParaRPr lang="en-CA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DCE9BBE-1E4A-41E9-9A18-97F8A9E7F83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1CBD0B3-576A-47AA-A9F3-0F513053535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C6745E-4E54-4561-A23A-18FE2834A80C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52513144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9248003-AAA5-4EE2-AFE5-F45B9E5D7B4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7D8DACD5-0BD2-435D-B480-8F564CC7925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AB59044-AF04-4C92-966E-96D8A0750A9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18210F-8F47-4556-9859-DDA34A5D551C}" type="datetimeFigureOut">
              <a:rPr lang="en-CA" smtClean="0"/>
              <a:t>2021-06-11</a:t>
            </a:fld>
            <a:endParaRPr lang="en-CA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3B71223-0F5B-4748-BA6C-B630BE5F2D4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06DC47E-9161-4C3F-966D-AC2BD55A6FE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C6745E-4E54-4561-A23A-18FE2834A80C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64274275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F40162D8-62C8-413D-B256-1E9E695DFA71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27B22038-9D39-4C1A-A7D9-F558EC22FB1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5AAD50D-474B-4A3F-BB00-26A632D7B5A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18210F-8F47-4556-9859-DDA34A5D551C}" type="datetimeFigureOut">
              <a:rPr lang="en-CA" smtClean="0"/>
              <a:t>2021-06-11</a:t>
            </a:fld>
            <a:endParaRPr lang="en-CA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E890150-B724-4BA1-9D1C-167059E3CF9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407DC19-4F4C-4BAB-BB05-7295E5E9F4D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C6745E-4E54-4561-A23A-18FE2834A80C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17337139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64EB710-3D28-424D-958D-CBC3EA508C4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6AE18EB-1C50-4EFE-B6E8-F0C55C264F2D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58C773F-486D-4256-9102-91DB568EE35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18210F-8F47-4556-9859-DDA34A5D551C}" type="datetimeFigureOut">
              <a:rPr lang="en-CA" smtClean="0"/>
              <a:t>2021-06-11</a:t>
            </a:fld>
            <a:endParaRPr lang="en-CA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8F09D3A-DE25-4590-8AE2-1DC87C47E3D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27B3AAA-821E-4A2E-8E3C-FD7358A17EF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C6745E-4E54-4561-A23A-18FE2834A80C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65387602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E7015DF-DD1A-4B9C-A13C-D382E95F6AE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AFC53848-E7D1-475B-9199-1244873F86F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3E37F4E-D6EB-488E-90EE-D8005DA2C8A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18210F-8F47-4556-9859-DDA34A5D551C}" type="datetimeFigureOut">
              <a:rPr lang="en-CA" smtClean="0"/>
              <a:t>2021-06-11</a:t>
            </a:fld>
            <a:endParaRPr lang="en-CA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8474792-5239-4307-8F55-8A06358D5FE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AD977D4-1F64-4A96-B7BE-4B782314ED7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C6745E-4E54-4561-A23A-18FE2834A80C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90218944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4605931-5802-42A3-96C1-9ED34257AC4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DC5140A-19E7-4DBD-9D1F-E78EAE7C1290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DE1F75E7-C2A6-4E63-A699-88C600E0740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03F255C1-FEAE-4FA3-A4BA-857891EDA3F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18210F-8F47-4556-9859-DDA34A5D551C}" type="datetimeFigureOut">
              <a:rPr lang="en-CA" smtClean="0"/>
              <a:t>2021-06-11</a:t>
            </a:fld>
            <a:endParaRPr lang="en-CA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1634B281-8DE5-4809-B774-954E5D1993D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BD8EA71A-93F5-462A-AD58-FB30FEF4A43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C6745E-4E54-4561-A23A-18FE2834A80C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15351908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48E9CC3-B713-4772-98B8-46949BDAAA0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BAA4D38D-EB0D-48B0-B303-7B76723AEE7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1531A391-941D-42D7-AE62-51236A3DCC8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0B014478-4D9B-42BD-B1A7-476A5C7A0158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CCEAC758-3391-48BA-9A6B-3F75D3A41C2C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E89642C3-B1A9-44AD-8ED5-3B83CAF2BD6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18210F-8F47-4556-9859-DDA34A5D551C}" type="datetimeFigureOut">
              <a:rPr lang="en-CA" smtClean="0"/>
              <a:t>2021-06-11</a:t>
            </a:fld>
            <a:endParaRPr lang="en-CA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401C3EC3-2968-4B57-838E-D6BABD0DCC0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65952032-25D2-4309-8261-B6FD4062CA5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C6745E-4E54-4561-A23A-18FE2834A80C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10521388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8174AAE-3523-44C1-A282-4C2DC58EF3E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530AB6A1-AD76-4D61-81BD-400F58A733C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18210F-8F47-4556-9859-DDA34A5D551C}" type="datetimeFigureOut">
              <a:rPr lang="en-CA" smtClean="0"/>
              <a:t>2021-06-11</a:t>
            </a:fld>
            <a:endParaRPr lang="en-CA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AA1585F5-DF82-4D32-B317-BEEB59F228C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140D4B86-3FFE-4519-9431-B5B1EB70EF5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C6745E-4E54-4561-A23A-18FE2834A80C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61019776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434540E4-8CFA-44B6-A14D-8D52EC4F224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18210F-8F47-4556-9859-DDA34A5D551C}" type="datetimeFigureOut">
              <a:rPr lang="en-CA" smtClean="0"/>
              <a:t>2021-06-11</a:t>
            </a:fld>
            <a:endParaRPr lang="en-CA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ED94E5BC-1261-458F-8699-FC683CABE6C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513405E3-78F5-4F2D-A140-AABAB90BA76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C6745E-4E54-4561-A23A-18FE2834A80C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428337822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9BCF907-BB18-4332-A227-0DA6F5BBEF7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6CB9E565-9281-470F-ADBC-116E2A02E5A4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82D9FC8C-74FF-4599-A611-2AAF86797E8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7F006B2E-E260-44B9-9DD6-C61239A89C7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18210F-8F47-4556-9859-DDA34A5D551C}" type="datetimeFigureOut">
              <a:rPr lang="en-CA" smtClean="0"/>
              <a:t>2021-06-11</a:t>
            </a:fld>
            <a:endParaRPr lang="en-CA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1CE18712-7EE6-4226-B3F5-57EC4409184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AA122CED-DE2D-4367-959A-CB9D4B423F6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C6745E-4E54-4561-A23A-18FE2834A80C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60031823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E730F0B-CD4A-4234-A674-7DA119AB402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7563DF66-6A1D-4952-B43F-86A277485F75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CA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ABAEB27A-B58C-42E7-91A5-45BA809C3AD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E2EE4286-2A4D-4197-8178-A064650DA4B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18210F-8F47-4556-9859-DDA34A5D551C}" type="datetimeFigureOut">
              <a:rPr lang="en-CA" smtClean="0"/>
              <a:t>2021-06-11</a:t>
            </a:fld>
            <a:endParaRPr lang="en-CA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D32C69F0-E6D0-41DC-B631-F8512C3E1FB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1E9F27FB-4572-4A2C-9B18-953E351D1B0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C6745E-4E54-4561-A23A-18FE2834A80C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56722849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9F1B5DBF-FCAA-4DE4-BBF7-2AE62FB4A84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D073EB14-ED3C-4F65-BCA8-C2A4B6EE1AD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D7E2ABF-2DC1-4CAC-A563-2C0514AD3C9A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118210F-8F47-4556-9859-DDA34A5D551C}" type="datetimeFigureOut">
              <a:rPr lang="en-CA" smtClean="0"/>
              <a:t>2021-06-11</a:t>
            </a:fld>
            <a:endParaRPr lang="en-CA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E46F0C6-D649-4D9E-BDB8-B73E12A3C85A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CA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2CB676A-5DAF-443C-92AF-314B039F2A72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5C6745E-4E54-4561-A23A-18FE2834A80C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38197847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jpeg"/><Relationship Id="rId3" Type="http://schemas.openxmlformats.org/officeDocument/2006/relationships/image" Target="../media/image1.jpg"/><Relationship Id="rId7" Type="http://schemas.openxmlformats.org/officeDocument/2006/relationships/image" Target="../media/image5.jpe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4.jpeg"/><Relationship Id="rId5" Type="http://schemas.openxmlformats.org/officeDocument/2006/relationships/image" Target="../media/image3.jpeg"/><Relationship Id="rId4" Type="http://schemas.openxmlformats.org/officeDocument/2006/relationships/image" Target="../media/image2.jpeg"/><Relationship Id="rId9" Type="http://schemas.openxmlformats.org/officeDocument/2006/relationships/image" Target="../media/image7.jpe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9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98ACF8A6-87CA-EE4A-8A6D-605691E6B774}"/>
              </a:ext>
            </a:extLst>
          </p:cNvPr>
          <p:cNvSpPr txBox="1"/>
          <p:nvPr/>
        </p:nvSpPr>
        <p:spPr>
          <a:xfrm>
            <a:off x="417909" y="244294"/>
            <a:ext cx="33214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547A02E6-0B5F-ED4A-AFAE-427EE25AEED6}"/>
              </a:ext>
            </a:extLst>
          </p:cNvPr>
          <p:cNvSpPr txBox="1"/>
          <p:nvPr/>
        </p:nvSpPr>
        <p:spPr>
          <a:xfrm>
            <a:off x="337735" y="3438102"/>
            <a:ext cx="33214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</a:p>
        </p:txBody>
      </p:sp>
      <p:sp>
        <p:nvSpPr>
          <p:cNvPr id="8" name="Rectangle 7">
            <a:extLst>
              <a:ext uri="{FF2B5EF4-FFF2-40B4-BE49-F238E27FC236}">
                <a16:creationId xmlns:a16="http://schemas.microsoft.com/office/drawing/2014/main" id="{5B1AF04F-2527-431C-ABE6-C12007650A2C}"/>
              </a:ext>
            </a:extLst>
          </p:cNvPr>
          <p:cNvSpPr/>
          <p:nvPr/>
        </p:nvSpPr>
        <p:spPr>
          <a:xfrm>
            <a:off x="3469824" y="255180"/>
            <a:ext cx="1254154" cy="1397454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CA"/>
          </a:p>
        </p:txBody>
      </p:sp>
      <p:sp>
        <p:nvSpPr>
          <p:cNvPr id="16" name="Rectangle 15">
            <a:extLst>
              <a:ext uri="{FF2B5EF4-FFF2-40B4-BE49-F238E27FC236}">
                <a16:creationId xmlns:a16="http://schemas.microsoft.com/office/drawing/2014/main" id="{F0328FA1-9EED-4BD1-BD6B-CBBFE1FC8928}"/>
              </a:ext>
            </a:extLst>
          </p:cNvPr>
          <p:cNvSpPr/>
          <p:nvPr/>
        </p:nvSpPr>
        <p:spPr>
          <a:xfrm>
            <a:off x="3467100" y="3501844"/>
            <a:ext cx="960546" cy="1397454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CA"/>
          </a:p>
        </p:txBody>
      </p:sp>
      <p:sp>
        <p:nvSpPr>
          <p:cNvPr id="14" name="Rectangle 13">
            <a:extLst>
              <a:ext uri="{FF2B5EF4-FFF2-40B4-BE49-F238E27FC236}">
                <a16:creationId xmlns:a16="http://schemas.microsoft.com/office/drawing/2014/main" id="{C8473C4A-4899-40EF-A98A-F17E6F63ABA4}"/>
              </a:ext>
            </a:extLst>
          </p:cNvPr>
          <p:cNvSpPr/>
          <p:nvPr/>
        </p:nvSpPr>
        <p:spPr>
          <a:xfrm>
            <a:off x="6629400" y="244292"/>
            <a:ext cx="1251572" cy="1397456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CA"/>
          </a:p>
        </p:txBody>
      </p:sp>
      <p:sp>
        <p:nvSpPr>
          <p:cNvPr id="22" name="Rectangle 21">
            <a:extLst>
              <a:ext uri="{FF2B5EF4-FFF2-40B4-BE49-F238E27FC236}">
                <a16:creationId xmlns:a16="http://schemas.microsoft.com/office/drawing/2014/main" id="{C77EA1C7-AF9B-4BAC-8154-ED57BF180632}"/>
              </a:ext>
            </a:extLst>
          </p:cNvPr>
          <p:cNvSpPr/>
          <p:nvPr/>
        </p:nvSpPr>
        <p:spPr>
          <a:xfrm>
            <a:off x="6734629" y="3541486"/>
            <a:ext cx="1319657" cy="1030514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CA"/>
          </a:p>
        </p:txBody>
      </p:sp>
      <p:pic>
        <p:nvPicPr>
          <p:cNvPr id="26" name="Picture 25" descr="Table&#10;&#10;Description automatically generated with medium confidence">
            <a:extLst>
              <a:ext uri="{FF2B5EF4-FFF2-40B4-BE49-F238E27FC236}">
                <a16:creationId xmlns:a16="http://schemas.microsoft.com/office/drawing/2014/main" id="{0B4AC655-0BDA-4890-AB1C-E7D5CAA9F536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461671" y="4641850"/>
            <a:ext cx="1152525" cy="1095375"/>
          </a:xfrm>
          <a:prstGeom prst="rect">
            <a:avLst/>
          </a:prstGeom>
        </p:spPr>
      </p:pic>
      <p:sp>
        <p:nvSpPr>
          <p:cNvPr id="6" name="Rectangle 5">
            <a:extLst>
              <a:ext uri="{FF2B5EF4-FFF2-40B4-BE49-F238E27FC236}">
                <a16:creationId xmlns:a16="http://schemas.microsoft.com/office/drawing/2014/main" id="{05737246-1675-4A30-807A-BDB670E9E7A9}"/>
              </a:ext>
            </a:extLst>
          </p:cNvPr>
          <p:cNvSpPr/>
          <p:nvPr/>
        </p:nvSpPr>
        <p:spPr>
          <a:xfrm>
            <a:off x="6629400" y="3598277"/>
            <a:ext cx="1191909" cy="872123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CA"/>
          </a:p>
        </p:txBody>
      </p:sp>
      <p:sp>
        <p:nvSpPr>
          <p:cNvPr id="25" name="Rectangle 24">
            <a:extLst>
              <a:ext uri="{FF2B5EF4-FFF2-40B4-BE49-F238E27FC236}">
                <a16:creationId xmlns:a16="http://schemas.microsoft.com/office/drawing/2014/main" id="{5E37343C-76F9-432E-BEA5-E16315A87DD3}"/>
              </a:ext>
            </a:extLst>
          </p:cNvPr>
          <p:cNvSpPr/>
          <p:nvPr/>
        </p:nvSpPr>
        <p:spPr>
          <a:xfrm>
            <a:off x="3130948" y="4600395"/>
            <a:ext cx="1254154" cy="1397454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CA"/>
          </a:p>
        </p:txBody>
      </p:sp>
      <p:sp>
        <p:nvSpPr>
          <p:cNvPr id="27" name="Rectangle 26">
            <a:extLst>
              <a:ext uri="{FF2B5EF4-FFF2-40B4-BE49-F238E27FC236}">
                <a16:creationId xmlns:a16="http://schemas.microsoft.com/office/drawing/2014/main" id="{86FD5950-A189-4D19-B2C7-A8293DBD0100}"/>
              </a:ext>
            </a:extLst>
          </p:cNvPr>
          <p:cNvSpPr/>
          <p:nvPr/>
        </p:nvSpPr>
        <p:spPr>
          <a:xfrm>
            <a:off x="6490067" y="3335611"/>
            <a:ext cx="1254154" cy="1397454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CA"/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1F300932-FCC2-8A40-B1E7-2AEA390EC8E9}"/>
              </a:ext>
            </a:extLst>
          </p:cNvPr>
          <p:cNvSpPr txBox="1"/>
          <p:nvPr/>
        </p:nvSpPr>
        <p:spPr>
          <a:xfrm>
            <a:off x="0" y="6275816"/>
            <a:ext cx="12192000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CA" sz="14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Figure S1: Principal Coordinate Analysis (PCA)of microbial communities based on A – ITS2 (fungal) and B – 16S rRNA (bacterial) communities Weighted </a:t>
            </a:r>
            <a:r>
              <a:rPr lang="en-CA" sz="1400" dirty="0" err="1">
                <a:latin typeface="Times New Roman" panose="02020603050405020304" pitchFamily="18" charset="0"/>
                <a:ea typeface="Times New Roman" panose="02020603050405020304" pitchFamily="18" charset="0"/>
              </a:rPr>
              <a:t>Unifrac</a:t>
            </a:r>
            <a:r>
              <a:rPr lang="en-CA" sz="14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 dissimilarity matrix. </a:t>
            </a:r>
            <a:r>
              <a:rPr lang="en-CA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oint sizes are proportionate to Shannon diversity index.</a:t>
            </a:r>
            <a:endParaRPr lang="en-US" sz="1400" dirty="0"/>
          </a:p>
        </p:txBody>
      </p:sp>
      <p:sp>
        <p:nvSpPr>
          <p:cNvPr id="28" name="Rectangle 27">
            <a:extLst>
              <a:ext uri="{FF2B5EF4-FFF2-40B4-BE49-F238E27FC236}">
                <a16:creationId xmlns:a16="http://schemas.microsoft.com/office/drawing/2014/main" id="{88A4AA9D-CC53-4ECA-A94D-48480CFB5E21}"/>
              </a:ext>
            </a:extLst>
          </p:cNvPr>
          <p:cNvSpPr/>
          <p:nvPr/>
        </p:nvSpPr>
        <p:spPr>
          <a:xfrm>
            <a:off x="6637869" y="181246"/>
            <a:ext cx="1254153" cy="1683979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CA"/>
          </a:p>
        </p:txBody>
      </p:sp>
      <p:sp>
        <p:nvSpPr>
          <p:cNvPr id="34" name="Rectangle 33">
            <a:extLst>
              <a:ext uri="{FF2B5EF4-FFF2-40B4-BE49-F238E27FC236}">
                <a16:creationId xmlns:a16="http://schemas.microsoft.com/office/drawing/2014/main" id="{22E264EC-DE72-4F89-ABC4-766D4CB5097E}"/>
              </a:ext>
            </a:extLst>
          </p:cNvPr>
          <p:cNvSpPr/>
          <p:nvPr/>
        </p:nvSpPr>
        <p:spPr>
          <a:xfrm>
            <a:off x="3146666" y="4600395"/>
            <a:ext cx="1254154" cy="1397454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CA"/>
          </a:p>
        </p:txBody>
      </p:sp>
      <p:sp>
        <p:nvSpPr>
          <p:cNvPr id="35" name="Rectangle 34">
            <a:extLst>
              <a:ext uri="{FF2B5EF4-FFF2-40B4-BE49-F238E27FC236}">
                <a16:creationId xmlns:a16="http://schemas.microsoft.com/office/drawing/2014/main" id="{59CE3EDE-C3E0-4D97-98B4-6A9A3D18EB50}"/>
              </a:ext>
            </a:extLst>
          </p:cNvPr>
          <p:cNvSpPr/>
          <p:nvPr/>
        </p:nvSpPr>
        <p:spPr>
          <a:xfrm>
            <a:off x="6637869" y="188918"/>
            <a:ext cx="1262622" cy="1463716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CA"/>
          </a:p>
        </p:txBody>
      </p:sp>
      <p:sp>
        <p:nvSpPr>
          <p:cNvPr id="36" name="Rectangle 35">
            <a:extLst>
              <a:ext uri="{FF2B5EF4-FFF2-40B4-BE49-F238E27FC236}">
                <a16:creationId xmlns:a16="http://schemas.microsoft.com/office/drawing/2014/main" id="{1FD3CDDE-0FD4-4D6E-AA9E-2078D1F252D2}"/>
              </a:ext>
            </a:extLst>
          </p:cNvPr>
          <p:cNvSpPr/>
          <p:nvPr/>
        </p:nvSpPr>
        <p:spPr>
          <a:xfrm>
            <a:off x="6715708" y="3496677"/>
            <a:ext cx="1184783" cy="973723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CA"/>
          </a:p>
        </p:txBody>
      </p:sp>
      <p:pic>
        <p:nvPicPr>
          <p:cNvPr id="44" name="Picture 43" descr="Chart, bubble chart&#10;&#10;Description automatically generated">
            <a:extLst>
              <a:ext uri="{FF2B5EF4-FFF2-40B4-BE49-F238E27FC236}">
                <a16:creationId xmlns:a16="http://schemas.microsoft.com/office/drawing/2014/main" id="{92443B85-BFE1-4F10-BC55-FA2CFD72FA4A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813627" y="3301372"/>
            <a:ext cx="3810000" cy="2857500"/>
          </a:xfrm>
          <a:prstGeom prst="rect">
            <a:avLst/>
          </a:prstGeom>
        </p:spPr>
      </p:pic>
      <p:pic>
        <p:nvPicPr>
          <p:cNvPr id="46" name="Picture 45" descr="Chart, scatter chart, bubble chart&#10;&#10;Description automatically generated">
            <a:extLst>
              <a:ext uri="{FF2B5EF4-FFF2-40B4-BE49-F238E27FC236}">
                <a16:creationId xmlns:a16="http://schemas.microsoft.com/office/drawing/2014/main" id="{8F8483D7-ADA9-43A1-BFD5-76C8216F774B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53274" y="3304315"/>
            <a:ext cx="3810000" cy="2857500"/>
          </a:xfrm>
          <a:prstGeom prst="rect">
            <a:avLst/>
          </a:prstGeom>
        </p:spPr>
      </p:pic>
      <p:sp>
        <p:nvSpPr>
          <p:cNvPr id="20" name="Rectangle 19">
            <a:extLst>
              <a:ext uri="{FF2B5EF4-FFF2-40B4-BE49-F238E27FC236}">
                <a16:creationId xmlns:a16="http://schemas.microsoft.com/office/drawing/2014/main" id="{C4A9C14D-5FFB-4AB6-B595-89B95BB20CD8}"/>
              </a:ext>
            </a:extLst>
          </p:cNvPr>
          <p:cNvSpPr/>
          <p:nvPr/>
        </p:nvSpPr>
        <p:spPr>
          <a:xfrm>
            <a:off x="3130948" y="4538718"/>
            <a:ext cx="1254154" cy="1075323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CA"/>
          </a:p>
        </p:txBody>
      </p:sp>
      <p:pic>
        <p:nvPicPr>
          <p:cNvPr id="48" name="Picture 47" descr="Chart, bubble chart&#10;&#10;Description automatically generated">
            <a:extLst>
              <a:ext uri="{FF2B5EF4-FFF2-40B4-BE49-F238E27FC236}">
                <a16:creationId xmlns:a16="http://schemas.microsoft.com/office/drawing/2014/main" id="{5D01AD99-29A5-4F76-AEB3-60BB131625C3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053752" y="3301372"/>
            <a:ext cx="3810000" cy="2857500"/>
          </a:xfrm>
          <a:prstGeom prst="rect">
            <a:avLst/>
          </a:prstGeom>
        </p:spPr>
      </p:pic>
      <p:sp>
        <p:nvSpPr>
          <p:cNvPr id="49" name="Rectangle 48">
            <a:extLst>
              <a:ext uri="{FF2B5EF4-FFF2-40B4-BE49-F238E27FC236}">
                <a16:creationId xmlns:a16="http://schemas.microsoft.com/office/drawing/2014/main" id="{74BC7386-65FE-412B-A449-419021D68111}"/>
              </a:ext>
            </a:extLst>
          </p:cNvPr>
          <p:cNvSpPr/>
          <p:nvPr/>
        </p:nvSpPr>
        <p:spPr>
          <a:xfrm>
            <a:off x="6561913" y="3496677"/>
            <a:ext cx="1182308" cy="973723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CA"/>
          </a:p>
        </p:txBody>
      </p:sp>
      <p:pic>
        <p:nvPicPr>
          <p:cNvPr id="53" name="Picture 52" descr="Chart, scatter chart, bubble chart&#10;&#10;Description automatically generated">
            <a:extLst>
              <a:ext uri="{FF2B5EF4-FFF2-40B4-BE49-F238E27FC236}">
                <a16:creationId xmlns:a16="http://schemas.microsoft.com/office/drawing/2014/main" id="{842B8462-D938-40F9-8EC1-A74752C67206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98170" y="266731"/>
            <a:ext cx="3810000" cy="2857500"/>
          </a:xfrm>
          <a:prstGeom prst="rect">
            <a:avLst/>
          </a:prstGeom>
        </p:spPr>
      </p:pic>
      <p:pic>
        <p:nvPicPr>
          <p:cNvPr id="55" name="Picture 54" descr="Chart, bubble chart&#10;&#10;Description automatically generated">
            <a:extLst>
              <a:ext uri="{FF2B5EF4-FFF2-40B4-BE49-F238E27FC236}">
                <a16:creationId xmlns:a16="http://schemas.microsoft.com/office/drawing/2014/main" id="{D55B07D5-B110-49EC-9F21-1EED5BF04066}"/>
              </a:ext>
            </a:extLst>
          </p:cNvPr>
          <p:cNvPicPr>
            <a:picLocks noChangeAspect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107717" y="268698"/>
            <a:ext cx="3810000" cy="2857500"/>
          </a:xfrm>
          <a:prstGeom prst="rect">
            <a:avLst/>
          </a:prstGeom>
        </p:spPr>
      </p:pic>
      <p:pic>
        <p:nvPicPr>
          <p:cNvPr id="51" name="Picture 50" descr="Chart, scatter chart, bubble chart&#10;&#10;Description automatically generated">
            <a:extLst>
              <a:ext uri="{FF2B5EF4-FFF2-40B4-BE49-F238E27FC236}">
                <a16:creationId xmlns:a16="http://schemas.microsoft.com/office/drawing/2014/main" id="{D00D0FBA-67A6-40F0-B8F9-A0F53B5F3C0C}"/>
              </a:ext>
            </a:extLst>
          </p:cNvPr>
          <p:cNvPicPr>
            <a:picLocks noChangeAspect="1"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821309" y="271470"/>
            <a:ext cx="3810000" cy="2857500"/>
          </a:xfrm>
          <a:prstGeom prst="rect">
            <a:avLst/>
          </a:prstGeom>
        </p:spPr>
      </p:pic>
      <p:sp>
        <p:nvSpPr>
          <p:cNvPr id="56" name="Rectangle 55">
            <a:extLst>
              <a:ext uri="{FF2B5EF4-FFF2-40B4-BE49-F238E27FC236}">
                <a16:creationId xmlns:a16="http://schemas.microsoft.com/office/drawing/2014/main" id="{BB144457-EB8E-410C-A77C-5C2C0B6EBBBD}"/>
              </a:ext>
            </a:extLst>
          </p:cNvPr>
          <p:cNvSpPr/>
          <p:nvPr/>
        </p:nvSpPr>
        <p:spPr>
          <a:xfrm>
            <a:off x="3146666" y="370029"/>
            <a:ext cx="943825" cy="1451654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n-CA"/>
          </a:p>
        </p:txBody>
      </p:sp>
      <p:sp>
        <p:nvSpPr>
          <p:cNvPr id="57" name="Rectangle 56">
            <a:extLst>
              <a:ext uri="{FF2B5EF4-FFF2-40B4-BE49-F238E27FC236}">
                <a16:creationId xmlns:a16="http://schemas.microsoft.com/office/drawing/2014/main" id="{254B66E9-C2FD-4A0F-8CCA-5B5325EB8123}"/>
              </a:ext>
            </a:extLst>
          </p:cNvPr>
          <p:cNvSpPr/>
          <p:nvPr/>
        </p:nvSpPr>
        <p:spPr>
          <a:xfrm>
            <a:off x="6637869" y="291694"/>
            <a:ext cx="1183440" cy="1451654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04168012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 descr="Chart&#10;&#10;Description automatically generated">
            <a:extLst>
              <a:ext uri="{FF2B5EF4-FFF2-40B4-BE49-F238E27FC236}">
                <a16:creationId xmlns:a16="http://schemas.microsoft.com/office/drawing/2014/main" id="{2BDEFE8A-89C4-4DCE-9318-358E04E333EC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86059" y="0"/>
            <a:ext cx="10619878" cy="3174379"/>
          </a:xfrm>
          <a:prstGeom prst="rect">
            <a:avLst/>
          </a:prstGeom>
        </p:spPr>
      </p:pic>
      <p:pic>
        <p:nvPicPr>
          <p:cNvPr id="7" name="Picture 6" descr="Diagram&#10;&#10;Description automatically generated with low confidence">
            <a:extLst>
              <a:ext uri="{FF2B5EF4-FFF2-40B4-BE49-F238E27FC236}">
                <a16:creationId xmlns:a16="http://schemas.microsoft.com/office/drawing/2014/main" id="{BF40CBD1-6B91-4F41-9D63-36A436386E2B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86059" y="3075462"/>
            <a:ext cx="10619878" cy="3185963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2946E5E3-E0C6-A54A-A745-0AD2A271A18D}"/>
              </a:ext>
            </a:extLst>
          </p:cNvPr>
          <p:cNvSpPr txBox="1"/>
          <p:nvPr/>
        </p:nvSpPr>
        <p:spPr>
          <a:xfrm>
            <a:off x="1" y="6334780"/>
            <a:ext cx="12192000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lvl="0" algn="ctr">
              <a:defRPr/>
            </a:pPr>
            <a:r>
              <a:rPr lang="en-CA" sz="14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Figure S2: </a:t>
            </a:r>
            <a:r>
              <a:rPr lang="en-CA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Eukaryotic taxa that were significantly overrepresented in comparison between </a:t>
            </a:r>
            <a:r>
              <a:rPr lang="en-CA" sz="14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prothioconazole and UTG. </a:t>
            </a:r>
            <a:r>
              <a:rPr lang="en-CA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rrected P-values (</a:t>
            </a:r>
            <a:r>
              <a:rPr lang="en-CA" sz="14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q</a:t>
            </a:r>
            <a:r>
              <a:rPr lang="en-CA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values) were calculated based on </a:t>
            </a:r>
            <a:r>
              <a:rPr lang="en-CA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enjamini</a:t>
            </a:r>
            <a:r>
              <a:rPr lang="en-CA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Hochberg FDR multiple test correction. Features with (Welch's </a:t>
            </a:r>
            <a:r>
              <a:rPr lang="en-CA" sz="14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</a:t>
            </a:r>
            <a:r>
              <a:rPr lang="en-CA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test) </a:t>
            </a:r>
            <a:r>
              <a:rPr lang="en-CA" sz="14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q </a:t>
            </a:r>
            <a:r>
              <a:rPr lang="en-CA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value &lt;0.05 were considered significant and were thus retained. 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6F398F75-D1A5-4DF7-AC75-BC1DDAF12738}"/>
              </a:ext>
            </a:extLst>
          </p:cNvPr>
          <p:cNvSpPr txBox="1"/>
          <p:nvPr/>
        </p:nvSpPr>
        <p:spPr>
          <a:xfrm>
            <a:off x="869878" y="1217294"/>
            <a:ext cx="1778072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CA" sz="1600" dirty="0" err="1">
                <a:latin typeface="Verdana" panose="020B0604030504040204" pitchFamily="34" charset="0"/>
                <a:ea typeface="Verdana" panose="020B0604030504040204" pitchFamily="34" charset="0"/>
                <a:cs typeface="Arial" panose="020B0604020202020204" pitchFamily="34" charset="0"/>
              </a:rPr>
              <a:t>Clavariaceae</a:t>
            </a:r>
            <a:r>
              <a:rPr lang="en-CA" dirty="0">
                <a:latin typeface="Verdana" panose="020B0604030504040204" pitchFamily="34" charset="0"/>
                <a:ea typeface="Verdana" panose="020B0604030504040204" pitchFamily="34" charset="0"/>
                <a:cs typeface="Arial" panose="020B0604020202020204" pitchFamily="34" charset="0"/>
              </a:rPr>
              <a:t> 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19E344C5-41A7-4A00-BD9B-E4E7CE844B82}"/>
              </a:ext>
            </a:extLst>
          </p:cNvPr>
          <p:cNvSpPr txBox="1"/>
          <p:nvPr/>
        </p:nvSpPr>
        <p:spPr>
          <a:xfrm>
            <a:off x="869878" y="4305948"/>
            <a:ext cx="2616272" cy="338554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txBody>
          <a:bodyPr wrap="square" rtlCol="0">
            <a:spAutoFit/>
          </a:bodyPr>
          <a:lstStyle/>
          <a:p>
            <a:r>
              <a:rPr lang="en-CA" sz="1600" i="1" dirty="0" err="1">
                <a:latin typeface="Verdana" panose="020B0604030504040204" pitchFamily="34" charset="0"/>
                <a:ea typeface="Verdana" panose="020B0604030504040204" pitchFamily="34" charset="0"/>
              </a:rPr>
              <a:t>Clavaria</a:t>
            </a:r>
            <a:r>
              <a:rPr lang="en-CA" sz="1600" i="1" dirty="0">
                <a:latin typeface="Verdana" panose="020B0604030504040204" pitchFamily="34" charset="0"/>
                <a:ea typeface="Verdana" panose="020B0604030504040204" pitchFamily="34" charset="0"/>
              </a:rPr>
              <a:t> </a:t>
            </a:r>
            <a:r>
              <a:rPr lang="en-CA" sz="1600" i="1" dirty="0" err="1">
                <a:latin typeface="Verdana" panose="020B0604030504040204" pitchFamily="34" charset="0"/>
                <a:ea typeface="Verdana" panose="020B0604030504040204" pitchFamily="34" charset="0"/>
              </a:rPr>
              <a:t>sphagnicola</a:t>
            </a:r>
            <a:endParaRPr lang="en-CA" sz="1600" i="1" dirty="0">
              <a:latin typeface="Verdana" panose="020B0604030504040204" pitchFamily="34" charset="0"/>
              <a:ea typeface="Verdana" panose="020B060403050404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02991185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5141</TotalTime>
  <Words>191</Words>
  <Application>Microsoft Office PowerPoint</Application>
  <PresentationFormat>Widescreen</PresentationFormat>
  <Paragraphs>12</Paragraphs>
  <Slides>2</Slides>
  <Notes>2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8" baseType="lpstr">
      <vt:lpstr>Arial</vt:lpstr>
      <vt:lpstr>Calibri</vt:lpstr>
      <vt:lpstr>Calibri Light</vt:lpstr>
      <vt:lpstr>Times New Roman</vt:lpstr>
      <vt:lpstr>Verdana</vt:lpstr>
      <vt:lpstr>Office Theme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ustin Lloyd</dc:creator>
  <cp:lastModifiedBy>Austin Lloyd</cp:lastModifiedBy>
  <cp:revision>47</cp:revision>
  <cp:lastPrinted>2021-05-19T14:33:28Z</cp:lastPrinted>
  <dcterms:created xsi:type="dcterms:W3CDTF">2021-05-03T00:04:27Z</dcterms:created>
  <dcterms:modified xsi:type="dcterms:W3CDTF">2021-06-13T14:04:54Z</dcterms:modified>
</cp:coreProperties>
</file>